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3" autoAdjust="0"/>
    <p:restoredTop sz="93944" autoAdjust="0"/>
  </p:normalViewPr>
  <p:slideViewPr>
    <p:cSldViewPr snapToGrid="0">
      <p:cViewPr varScale="1">
        <p:scale>
          <a:sx n="111" d="100"/>
          <a:sy n="111" d="100"/>
        </p:scale>
        <p:origin x="57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A1A297-8C75-41CF-A225-7B7227629211}" type="datetimeFigureOut">
              <a:rPr lang="ko-KR" altLang="en-US" smtClean="0"/>
              <a:t>2024. 3. 3.</a:t>
            </a:fld>
            <a:endParaRPr lang="ko-KR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1DF6F0-3125-4BB6-918B-8D4B5DF6E6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1920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FD6280-4D94-450C-93DE-CF6113D0E6B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69997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572604-565E-087C-1C29-967AC9D2B8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2BD1CAB-24E4-30D9-0ADE-970C7F1977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/>
              <a:t>Click to edit Master subtitle style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0982FC-EA1A-BDB6-E47B-3B9A83E72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A49C0-5DD7-4D6A-9E65-949126780AD0}" type="datetimeFigureOut">
              <a:rPr lang="ko-KR" altLang="en-US" smtClean="0"/>
              <a:t>2024. 3. 3.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FE0BA3-C5F7-8156-F02E-834290C2A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6B1D10-12CE-6F8B-4464-1F4295FDB8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D3B3-1C4B-4A3A-93C1-EED8B3506C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1453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285EBD-9661-2E26-5C77-BBEB88EB9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767B7A-D6A3-92FB-36CA-9F2C41D925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D1A1E4-C179-4148-6094-1F00CDB43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A49C0-5DD7-4D6A-9E65-949126780AD0}" type="datetimeFigureOut">
              <a:rPr lang="ko-KR" altLang="en-US" smtClean="0"/>
              <a:t>2024. 3. 3.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C887E3-5A2E-B5FC-3F94-9A2B599D3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7C0DAA-12FB-B531-B21B-6A9767164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D3B3-1C4B-4A3A-93C1-EED8B3506C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3176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94109D7-980F-6680-35D8-755F9F1FDF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1E9249-741D-1F93-89A4-51FCD511E5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5F1036-8A8C-85E9-C535-55C4DE8AC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A49C0-5DD7-4D6A-9E65-949126780AD0}" type="datetimeFigureOut">
              <a:rPr lang="ko-KR" altLang="en-US" smtClean="0"/>
              <a:t>2024. 3. 3.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02457B-DADC-4151-C046-DEFD9EFBC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D18C89-C3C3-8369-BA13-F6CB9261C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D3B3-1C4B-4A3A-93C1-EED8B3506C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803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53D2F9-7074-3B49-D449-04D77D318D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30DAFC-0D83-FEBE-F237-6E9F4925E0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9C7D60-7253-D077-DFCF-337030550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A49C0-5DD7-4D6A-9E65-949126780AD0}" type="datetimeFigureOut">
              <a:rPr lang="ko-KR" altLang="en-US" smtClean="0"/>
              <a:t>2024. 3. 3.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7F472D-E981-4188-29E2-DCDED54DE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55120A-5FF5-D29F-FCD8-E7856F301D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D3B3-1C4B-4A3A-93C1-EED8B3506C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9206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EB8EA-C86B-2514-0929-9819651584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398621-617D-7683-68C5-789EF1A19F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D479B-4290-0B04-9BD0-F88B84CBBE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A49C0-5DD7-4D6A-9E65-949126780AD0}" type="datetimeFigureOut">
              <a:rPr lang="ko-KR" altLang="en-US" smtClean="0"/>
              <a:t>2024. 3. 3.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0FA913-BDC6-76C6-FE4C-358460F61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EF9F94-1072-7B21-C8F2-8BDF092FD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D3B3-1C4B-4A3A-93C1-EED8B3506C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50716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9A07D6-6E5A-3585-5183-4A0B607889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93C0D0-9119-B677-8084-5C02E9723E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BEF1A9-190E-27B4-2968-3BE2313F3D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4BBCF7-877A-790C-4BEF-3180E28EC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A49C0-5DD7-4D6A-9E65-949126780AD0}" type="datetimeFigureOut">
              <a:rPr lang="ko-KR" altLang="en-US" smtClean="0"/>
              <a:t>2024. 3. 3.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51A785-EA4A-88E5-FD92-0121F8C6C7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CC3FA7-7F1C-E680-37BE-DF62AE2A8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D3B3-1C4B-4A3A-93C1-EED8B3506C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4115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92A5A5-CDC0-3A8A-3CB6-2657AD3626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D99D3D-E0BC-4A44-CD0B-38A7C4B973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EABDA2-5201-07A3-4D88-9C377EDD84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6B5C5FF-F34F-ED47-D4C1-07DE981E86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74EF81-BA7D-447B-85BE-8484DF291A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5B5681-F6DB-BC3F-AAE4-C21ED1615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A49C0-5DD7-4D6A-9E65-949126780AD0}" type="datetimeFigureOut">
              <a:rPr lang="ko-KR" altLang="en-US" smtClean="0"/>
              <a:t>2024. 3. 3.</a:t>
            </a:fld>
            <a:endParaRPr lang="ko-KR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21F2E4-3C1D-5BAC-3552-E55CEDC512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01511A-5312-AFC2-EF47-A6A2F93E3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D3B3-1C4B-4A3A-93C1-EED8B3506C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1226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404AA1-89E1-D045-52A3-773BFA6E1A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7E93C4-0B49-2198-2D3D-FCE4B8A74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A49C0-5DD7-4D6A-9E65-949126780AD0}" type="datetimeFigureOut">
              <a:rPr lang="ko-KR" altLang="en-US" smtClean="0"/>
              <a:t>2024. 3. 3.</a:t>
            </a:fld>
            <a:endParaRPr lang="ko-KR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C6F2C4-C536-3C14-6F94-B429BE643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2C44286-FF51-52C3-DEA4-7DCFA76FC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D3B3-1C4B-4A3A-93C1-EED8B3506C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9335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04F635B-2770-3FF4-834B-321F932E0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A49C0-5DD7-4D6A-9E65-949126780AD0}" type="datetimeFigureOut">
              <a:rPr lang="ko-KR" altLang="en-US" smtClean="0"/>
              <a:t>2024. 3. 3.</a:t>
            </a:fld>
            <a:endParaRPr lang="ko-KR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D2B842A-EC5C-010E-AF25-FB68107D4C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26BC91-B773-3445-46AD-E322A3DF5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D3B3-1C4B-4A3A-93C1-EED8B3506C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5041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F2C399-432C-B692-BCA4-A549E49FFD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67074B-FA1D-60EF-AFB1-F198F32CA1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874510-E01E-CBF0-E26B-1E66145FAE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D23A30-3F53-A66A-BF95-66FF599B3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A49C0-5DD7-4D6A-9E65-949126780AD0}" type="datetimeFigureOut">
              <a:rPr lang="ko-KR" altLang="en-US" smtClean="0"/>
              <a:t>2024. 3. 3.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C5FEE9-7C4D-FD34-4833-D0577527E0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3AAF9B-03C4-4875-BA48-55A13CDCE5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D3B3-1C4B-4A3A-93C1-EED8B3506C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7771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AE073C-D3F7-22BD-0862-EC28751CC6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C1DBB6-FD11-D067-F889-11FECFF5D7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BDA7B3-EB25-F36C-12C1-2A7E2A035A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10E034-B8B4-EFC8-ED3F-3F87571AE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A49C0-5DD7-4D6A-9E65-949126780AD0}" type="datetimeFigureOut">
              <a:rPr lang="ko-KR" altLang="en-US" smtClean="0"/>
              <a:t>2024. 3. 3.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298225-270D-2279-A40A-CA7CDBADB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49276C-44DE-2F22-8C48-447CD3990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D3B3-1C4B-4A3A-93C1-EED8B3506C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0001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D0E46D3-B22C-03BE-FD7B-B085F70366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8039BE-1797-0C41-1278-AFA31C05FD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4ED6BA-103B-8A91-2F02-4EB93A981A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0A49C0-5DD7-4D6A-9E65-949126780AD0}" type="datetimeFigureOut">
              <a:rPr lang="ko-KR" altLang="en-US" smtClean="0"/>
              <a:t>2024. 3. 3.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D6E879-1D45-6538-8EA2-C09B3F124B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3D77B8-DB5B-6F04-913F-2F0B678273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B1D3B3-1C4B-4A3A-93C1-EED8B3506C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5177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그림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4967" y="930947"/>
            <a:ext cx="9402066" cy="49961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직사각형 2"/>
          <p:cNvSpPr/>
          <p:nvPr/>
        </p:nvSpPr>
        <p:spPr>
          <a:xfrm>
            <a:off x="978278" y="761265"/>
            <a:ext cx="10793175" cy="3393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 </a:t>
            </a:r>
            <a:r>
              <a:rPr lang="en-US" sz="1600" b="0" i="0">
                <a:solidFill>
                  <a:srgbClr val="0D0D0D"/>
                </a:solidFill>
                <a:effectLst/>
                <a:latin typeface="Söhne"/>
              </a:rPr>
              <a:t>Comparison of Propensity Score Distributions Before and After Matching</a:t>
            </a:r>
            <a:endParaRPr lang="ko-KR" altLang="en-US" sz="160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9852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4</Words>
  <Application>Microsoft Macintosh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맑은 고딕</vt:lpstr>
      <vt:lpstr>Söhne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 Jeonghoon</dc:creator>
  <cp:lastModifiedBy>suein choi</cp:lastModifiedBy>
  <cp:revision>5</cp:revision>
  <dcterms:created xsi:type="dcterms:W3CDTF">2023-09-03T06:13:08Z</dcterms:created>
  <dcterms:modified xsi:type="dcterms:W3CDTF">2024-03-03T03:14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Fasoo_Trace_ID">
    <vt:lpwstr>eyJub2RlMSI6eyJkc2QiOiIwMTAwMDAwMDAwMDAzMTk0IiwibG9nVGltZSI6IjIwMjMtMTEtMDdUMDE6NDE6MjFaIiwicElEIjoxLCJ0cmFjZUlkIjoiODRGMTk0RjJGMzM5NEE4N0JDQTdENDVFMzc5MUVBMjUiLCJ1c2VyQ29kZSI6IjIxMTAwNDAxIn0sIm5vZGUyIjp7ImRzZCI6IjAxMDAwMDAwMDAwMDMxOTQiLCJsb2dUaW1lIjoiMjAyMy0xMS0wN1QwMjoyNToyM1oiLCJwSUQiOjEsInRyYWNlSWQiOiJGMEIwMTRFM0NDNTA0ODZGOTc2MUE4NjY0MzFEMzUxRCIsInVzZXJDb2RlIjoiMjExMDA0MDEifSwibm9kZTMiOnsiZHNkIjoiMDAwMDAwMDAwMDAwMDAwMCIsImxvZ1RpbWUiOiIyMDIzLTExLTE2VDA1OjAyOjM1WiIsInBJRCI6MjA0OCwidHJhY2VJZCI6IkI0OERDRkQ4MDE0MjREMTJCQUE4QjY4NDVBMDM3RjQ0IiwidXNlckNvZGUiOiIyMTEwMDQwMSJ9LCJub2RlNCI6eyJkc2QiOiIwMTAwMDAwMDAwMDAzMTk0IiwibG9nVGltZSI6IjIwMjMtMTEtMTZUMjI6MzU6MDlaIiwicElEIjoxLCJ0cmFjZUlkIjoiRUQ1NDZEMUYwNzQ2NEJFM0EzOTNBOTVBMTQwMDc5REIiLCJ1c2VyQ29kZSI6IjIxMTAwNDAxIn0sIm5vZGU1Ijp7ImRzZCI6IjAwMDAwMDAwMDAwMDAwMDAiLCJsb2dUaW1lIjoiMjAyMy0xMS0xNlQyMzowMzo0NloiLCJwSUQiOjIwNDgsInRyYWNlSWQiOiJBQzQ0MTg5ODNDQTE0MEUzQUZFMjIyODE3Qzc5Q0E2NCIsInVzZXJDb2RlIjoiMjExMDA0MDEifSwibm9kZUNvdW50Ijo4fQ==</vt:lpwstr>
  </property>
  <property fmtid="{D5CDD505-2E9C-101B-9397-08002B2CF9AE}" pid="3" name="FDRClass">
    <vt:lpwstr>0</vt:lpwstr>
  </property>
  <property fmtid="{D5CDD505-2E9C-101B-9397-08002B2CF9AE}" pid="4" name="FDRSet">
    <vt:lpwstr>manual</vt:lpwstr>
  </property>
</Properties>
</file>